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2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1963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0431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3518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8724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9072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8286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9962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2319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726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2911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8546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5AA132-1952-4950-8CFC-C75F69CDD741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347B2-ABE3-4C78-BB8E-2466CC4EC6A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4995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058581"/>
              </p:ext>
            </p:extLst>
          </p:nvPr>
        </p:nvGraphicFramePr>
        <p:xfrm>
          <a:off x="2982889" y="1015999"/>
          <a:ext cx="5580330" cy="4028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8" r:id="rId3" imgW="9435556" imgH="6812314" progId="Prism8.Document">
                  <p:embed/>
                </p:oleObj>
              </mc:Choice>
              <mc:Fallback>
                <p:oleObj name="Prism 8" r:id="rId3" imgW="9435556" imgH="68123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82889" y="1015999"/>
                        <a:ext cx="5580330" cy="4028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7499" y="7499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352800" y="5134708"/>
            <a:ext cx="486898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200" b="1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Pearson correlation between the IL-6 level produced by isolated B cells from PTB patients within a 72-h-culture in medium and the gestational week when PTB occurred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0407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Breitbild</PresentationFormat>
  <Paragraphs>3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8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sse, Mandy</dc:creator>
  <cp:lastModifiedBy>Busse, Mandy</cp:lastModifiedBy>
  <cp:revision>4</cp:revision>
  <dcterms:created xsi:type="dcterms:W3CDTF">2019-12-16T11:57:56Z</dcterms:created>
  <dcterms:modified xsi:type="dcterms:W3CDTF">2020-02-07T13:00:47Z</dcterms:modified>
</cp:coreProperties>
</file>